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3E90E474-AA40-0547-8148-23EDFA8C7F40}">
          <p14:sldIdLst>
            <p14:sldId id="272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922" autoAdjust="0"/>
  </p:normalViewPr>
  <p:slideViewPr>
    <p:cSldViewPr snapToGrid="0" snapToObjects="1" showGuides="1">
      <p:cViewPr>
        <p:scale>
          <a:sx n="100" d="100"/>
          <a:sy n="100" d="100"/>
        </p:scale>
        <p:origin x="-1632" y="79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0A157D-C987-9647-8EFA-79CB5430D7C9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CCF4A7-2F8A-0B4A-9B39-AE0D624E8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640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672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175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8865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231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2123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9740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81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960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315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655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252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50415F-2263-9340-B64C-2F0F0E394398}" type="datetimeFigureOut">
              <a:rPr kumimoji="1" lang="ja-JP" altLang="en-US" smtClean="0"/>
              <a:t>14/03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86FFC-270C-3E4A-842C-461E910FA7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127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5740204"/>
              </p:ext>
            </p:extLst>
          </p:nvPr>
        </p:nvGraphicFramePr>
        <p:xfrm>
          <a:off x="185655" y="3263894"/>
          <a:ext cx="6486690" cy="2092480"/>
        </p:xfrm>
        <a:graphic>
          <a:graphicData uri="http://schemas.openxmlformats.org/drawingml/2006/table">
            <a:tbl>
              <a:tblPr/>
              <a:tblGrid>
                <a:gridCol w="648669"/>
                <a:gridCol w="648669"/>
                <a:gridCol w="648669"/>
                <a:gridCol w="648669"/>
                <a:gridCol w="648669"/>
                <a:gridCol w="648669"/>
                <a:gridCol w="648669"/>
                <a:gridCol w="648669"/>
                <a:gridCol w="648669"/>
                <a:gridCol w="648669"/>
              </a:tblGrid>
              <a:tr h="209248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dCUL1B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bCUL1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UL1A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UL1B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iCUL1-G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iCUL1-C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hCUL1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pCUL1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tCUL1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92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dCUL1A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8.5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1.7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.6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1.2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5.9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0.2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6.2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6.4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2.2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92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MdCUL1B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―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6.9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1.9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6.9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5.2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6.3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5.4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58.4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8.6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2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bCUL1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―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4.4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6.1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0.5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0.7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0.5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9.0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2.8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2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UL1A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―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5.0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9.3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3.3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9.6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9.6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4.6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2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avCUL1B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―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1.0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2.0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1.0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9.4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3.3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2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iCUL1-G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―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0.4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99.4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3.7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8.8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2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iCUL1-C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―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0.4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9.1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82.8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2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hCUL1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―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3.7 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78.8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92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pCUL1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　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―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68.2</a:t>
                      </a:r>
                    </a:p>
                  </a:txBody>
                  <a:tcPr marL="10462" marR="10462" marT="1046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89087099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01</TotalTime>
  <Words>79</Words>
  <Application>Microsoft Macintosh PowerPoint</Application>
  <PresentationFormat>A4 210x297 mm</PresentationFormat>
  <Paragraphs>7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千葉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南川 舞</dc:creator>
  <cp:lastModifiedBy>南川 舞</cp:lastModifiedBy>
  <cp:revision>84</cp:revision>
  <cp:lastPrinted>2014-01-17T05:56:58Z</cp:lastPrinted>
  <dcterms:created xsi:type="dcterms:W3CDTF">2013-11-20T09:12:09Z</dcterms:created>
  <dcterms:modified xsi:type="dcterms:W3CDTF">2014-03-20T06:03:24Z</dcterms:modified>
</cp:coreProperties>
</file>